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FE2614-3A63-47D9-ACF4-3A2411279DD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3E9CD2-DC92-45C6-829B-65FF2794A5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7688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97013" y="1200150"/>
            <a:ext cx="4321175" cy="324008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3. Need fuller disc data from </a:t>
            </a:r>
            <a:r>
              <a:rPr lang="en-US" dirty="0" err="1"/>
              <a:t>visha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872F96-EA7C-4941-A4E1-204FA6C31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529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EDBE60-7B6F-4A81-B7C8-B503158E77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1E1B72F-E37A-42AC-A7D2-3CB84971CE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D40FC3-D853-467D-8FAF-FBF345C24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8F65F8-A291-4474-A47E-45D034D16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8F7F2F-744A-48DF-AB7B-09804CB18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590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8EB06-3AA2-46C6-A2C8-E5893E274E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7DBDBB-1774-4D7D-A454-242BCDE980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3EA840-A4BB-4FE1-A246-3F2036CF1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39653-7955-42F1-BBA4-E93EE31145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B032C1-FF5E-4EFB-8D37-31B24B650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389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E8A000-DE48-4DFC-A91E-1AF6D8CD50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A184B3-DB36-4CCB-BCE8-81C1A4C9AF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C3C025-6A9B-4843-90C3-31DD55704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7A2C3D-9490-4E90-AF30-711DEED52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D47277-6D1F-41FF-9A1E-10457045B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824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471BC6-07C1-482B-9559-34749BC216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FA4982-BE9A-4A51-A397-289924552E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7DE758-91AC-4685-902D-E480E4F8F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7B60B8-1797-49A2-9251-0D1B79392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371A25-503B-41A4-BD66-85A93A72A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396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95235F-667E-46D8-93C7-C50F22A5F7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EF5C7F-5B99-49EA-9391-F99645D330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5EE822-EA2C-4FA9-93A1-5FD01F267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D061CA-23C3-4CA2-A6CD-148E11183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AF8414-3583-4618-89BF-CB0A5F18F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861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9CD83D-8C04-4375-BA23-798DACD907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4E351E-EAF0-4E27-B249-1A5F351473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FDE52E-E5EC-46D8-86DD-7D0568576E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04BA60-5EA3-4D19-BF25-F9A27A2A1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5ED813-FAA1-4BF0-9AF0-DE0E71CF5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520411-76F6-4ADE-BC08-32118CFC6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270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00A987-5D02-4592-B97F-95A7FDE03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63733C-9116-4863-9FBF-071A780223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A28EC4-3A9C-4B89-BE6A-E7584BE694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9F828C-83CF-4FD6-BF37-5E7678D80F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8032478-A79A-486B-A8E5-69DF858F08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6891A7E-7478-4014-A5CA-8269F7A1B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5FE682-5F1E-45A1-A043-F2F594F0E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D9A9F68-DEAF-416B-9238-EC7F057EE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697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257B89-FE2A-4416-8AC7-9A13B5372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8AA0A0-F8B6-44D7-AD9A-6DB51FA6F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31DACF-BFA1-460D-B43B-8D1F8F83D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B9F2CB-3B49-4993-AB01-A1D02E656D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752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990C4B-FCA9-409F-A600-C59C4B4AB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B937E2-7AD4-4B8A-88C1-AA6625D6B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822217-4BFF-4EA6-9D16-A2A937B51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863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A73C01-4036-42A0-B935-3E69BD3C74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38B145-8896-4E4F-95EF-71474D3AB4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177D27-B506-44D0-A49E-2138DEC950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2AAA3E-3506-459D-86DC-E69BFBC0B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8A9667-2D3C-430E-98A3-9338CA943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314E75-D3DC-4DB3-88BB-9BC0675DB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583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63CFFC-D3CB-462F-8404-9679BA43A3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4F516A-68C2-445A-8B94-3DEE60BC62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FC80B2-A029-4905-8279-2228929A3F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6988E9-F315-4708-959D-17674CC12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795FFA-B830-4DB3-B4CB-D71066D26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EA19FD-46A1-475E-A0EB-5908771E11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142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496984-1122-4EE0-9C06-EDFE78BA2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DFEC8C-8BF0-4188-8AE6-A9EF5A8AFD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0B3745-2815-4500-8EA8-2B9A75F27B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2A69F-231A-435E-B12F-CFDC6DF7DF4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3D3844-8EB0-4DD8-92BB-E9D2762576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C83094-8382-4E43-8036-636B2CA3FC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14F187-0842-478E-8459-E58822FF8E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568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1EF2ADA-2522-42F8-A712-ADA496D552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4626" y="1008396"/>
            <a:ext cx="6462243" cy="3615992"/>
          </a:xfrm>
          <a:prstGeom prst="rect">
            <a:avLst/>
          </a:prstGeom>
        </p:spPr>
      </p:pic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2683141" y="797718"/>
          <a:ext cx="6431305" cy="50535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31305">
                  <a:extLst>
                    <a:ext uri="{9D8B030D-6E8A-4147-A177-3AD203B41FA5}">
                      <a16:colId xmlns:a16="http://schemas.microsoft.com/office/drawing/2014/main" val="2891490085"/>
                    </a:ext>
                  </a:extLst>
                </a:gridCol>
              </a:tblGrid>
              <a:tr h="3947396">
                <a:tc>
                  <a:txBody>
                    <a:bodyPr/>
                    <a:lstStyle/>
                    <a:p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7681369"/>
                  </a:ext>
                </a:extLst>
              </a:tr>
              <a:tr h="110611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Supplemental Figure 3. Measurement of bacterial burden using in vivo bioluminescence. </a:t>
                      </a:r>
                      <a:r>
                        <a:rPr lang="en-US" sz="800" b="0" i="1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S. aureus 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possessing the bioluminescent construct in a stable plasmid (Xen36) in two inoculums (1*10</a:t>
                      </a:r>
                      <a:r>
                        <a:rPr lang="en-US" sz="8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 or 1*10</a:t>
                      </a:r>
                      <a:r>
                        <a:rPr lang="en-US" sz="8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3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 CFU) or no bacteria as a control were inoculated into the dorsal cervical subcutaneous space of mice in the presence of either a cortical allograft implant or stainless steel disc. Bacterial counts as measured by in vivo </a:t>
                      </a:r>
                      <a:r>
                        <a:rPr lang="en-US" sz="800" b="0" i="1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S. aureus 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bioluminescence (total flux [photons/s/cm2]</a:t>
                      </a:r>
                      <a:r>
                        <a:rPr lang="en-US" sz="800" b="0" i="0" u="none" strike="noStrike" kern="1200" baseline="0" dirty="0" err="1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sem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 [logarithmic scale]). Error bars represent standard error of the mean. </a:t>
                      </a:r>
                      <a:r>
                        <a:rPr lang="en-US" sz="800" b="0" dirty="0">
                          <a:solidFill>
                            <a:schemeClr val="tx1"/>
                          </a:solidFill>
                          <a:latin typeface="Arial"/>
                          <a:ea typeface="Calibri" panose="020F0502020204030204" pitchFamily="34" charset="0"/>
                          <a:cs typeface="Arial"/>
                        </a:rPr>
                        <a:t>†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: p &lt; 0.05 compared to sterile in the </a:t>
                      </a:r>
                      <a:r>
                        <a:rPr lang="en-US" sz="800" b="0" kern="12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mixed effects regression model using a group-by-time interaction term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. </a:t>
                      </a:r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04944133"/>
                  </a:ext>
                </a:extLst>
              </a:tr>
            </a:tbl>
          </a:graphicData>
        </a:graphic>
      </p:graphicFrame>
      <p:sp>
        <p:nvSpPr>
          <p:cNvPr id="66" name="Rectangle 65">
            <a:extLst>
              <a:ext uri="{FF2B5EF4-FFF2-40B4-BE49-F238E27FC236}">
                <a16:creationId xmlns:a16="http://schemas.microsoft.com/office/drawing/2014/main" id="{320E61A3-DA08-4D0E-BA06-7EF7C676CFFD}"/>
              </a:ext>
            </a:extLst>
          </p:cNvPr>
          <p:cNvSpPr/>
          <p:nvPr/>
        </p:nvSpPr>
        <p:spPr>
          <a:xfrm>
            <a:off x="3808023" y="2029027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4B5EDE31-12A4-49F3-B2AD-23183C5687B2}"/>
              </a:ext>
            </a:extLst>
          </p:cNvPr>
          <p:cNvSpPr/>
          <p:nvPr/>
        </p:nvSpPr>
        <p:spPr>
          <a:xfrm>
            <a:off x="4178565" y="1743196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E2F8A760-A735-401C-9B2C-550BC4C20C40}"/>
              </a:ext>
            </a:extLst>
          </p:cNvPr>
          <p:cNvSpPr/>
          <p:nvPr/>
        </p:nvSpPr>
        <p:spPr>
          <a:xfrm>
            <a:off x="4549107" y="1664393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E90A94EE-7119-4850-A5A5-B44A2B214632}"/>
              </a:ext>
            </a:extLst>
          </p:cNvPr>
          <p:cNvSpPr/>
          <p:nvPr/>
        </p:nvSpPr>
        <p:spPr>
          <a:xfrm>
            <a:off x="4897446" y="1608933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CE2FE465-6ECD-4180-B2F5-E0E6710D79A9}"/>
              </a:ext>
            </a:extLst>
          </p:cNvPr>
          <p:cNvSpPr/>
          <p:nvPr/>
        </p:nvSpPr>
        <p:spPr>
          <a:xfrm>
            <a:off x="5257315" y="1665283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F0269485-B8A2-404F-AEA9-BB6437BB7F64}"/>
              </a:ext>
            </a:extLst>
          </p:cNvPr>
          <p:cNvSpPr/>
          <p:nvPr/>
        </p:nvSpPr>
        <p:spPr>
          <a:xfrm>
            <a:off x="5623808" y="2023424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0B6A089-4C3F-4CC3-9988-E56B741300D7}"/>
              </a:ext>
            </a:extLst>
          </p:cNvPr>
          <p:cNvSpPr/>
          <p:nvPr/>
        </p:nvSpPr>
        <p:spPr>
          <a:xfrm>
            <a:off x="5961162" y="1920800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90F06FAE-FEFA-47F7-A1EE-3E76D651E46F}"/>
              </a:ext>
            </a:extLst>
          </p:cNvPr>
          <p:cNvSpPr/>
          <p:nvPr/>
        </p:nvSpPr>
        <p:spPr>
          <a:xfrm>
            <a:off x="6334525" y="1551468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C1AFA34A-75E6-4787-8CC8-2A9D47974C27}"/>
              </a:ext>
            </a:extLst>
          </p:cNvPr>
          <p:cNvSpPr/>
          <p:nvPr/>
        </p:nvSpPr>
        <p:spPr>
          <a:xfrm>
            <a:off x="6678299" y="1421181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3DEFF552-622E-467C-A86D-91AA9B4A1EBA}"/>
              </a:ext>
            </a:extLst>
          </p:cNvPr>
          <p:cNvSpPr/>
          <p:nvPr/>
        </p:nvSpPr>
        <p:spPr>
          <a:xfrm>
            <a:off x="7069587" y="1673234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1829CE3D-DD8E-44E2-9937-D864CFB2F56D}"/>
              </a:ext>
            </a:extLst>
          </p:cNvPr>
          <p:cNvSpPr/>
          <p:nvPr/>
        </p:nvSpPr>
        <p:spPr>
          <a:xfrm>
            <a:off x="3810321" y="2290132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schemeClr val="bg2">
                    <a:lumMod val="50000"/>
                  </a:schemeClr>
                </a:solidFill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solidFill>
                <a:schemeClr val="bg2">
                  <a:lumMod val="50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630D473F-5218-4539-A429-2130D74A0285}"/>
              </a:ext>
            </a:extLst>
          </p:cNvPr>
          <p:cNvSpPr/>
          <p:nvPr/>
        </p:nvSpPr>
        <p:spPr>
          <a:xfrm>
            <a:off x="4174516" y="2162377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schemeClr val="bg2">
                    <a:lumMod val="50000"/>
                  </a:schemeClr>
                </a:solidFill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solidFill>
                <a:schemeClr val="bg2">
                  <a:lumMod val="50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E15DDB03-5098-49CE-B283-57ABEBBF7B41}"/>
              </a:ext>
            </a:extLst>
          </p:cNvPr>
          <p:cNvSpPr/>
          <p:nvPr/>
        </p:nvSpPr>
        <p:spPr>
          <a:xfrm>
            <a:off x="3818556" y="2668627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255C1CD7-9241-4615-859D-2CCA92018490}"/>
              </a:ext>
            </a:extLst>
          </p:cNvPr>
          <p:cNvSpPr/>
          <p:nvPr/>
        </p:nvSpPr>
        <p:spPr>
          <a:xfrm>
            <a:off x="4174516" y="2416420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9744B738-A0A5-499B-9C67-3DE01C55B566}"/>
              </a:ext>
            </a:extLst>
          </p:cNvPr>
          <p:cNvSpPr/>
          <p:nvPr/>
        </p:nvSpPr>
        <p:spPr>
          <a:xfrm>
            <a:off x="4914251" y="2539531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65937ED4-2928-4E83-92C7-32533850531F}"/>
              </a:ext>
            </a:extLst>
          </p:cNvPr>
          <p:cNvSpPr/>
          <p:nvPr/>
        </p:nvSpPr>
        <p:spPr>
          <a:xfrm>
            <a:off x="4549107" y="2483961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CD982A1D-8B22-4701-9323-3547BCBEDD8D}"/>
              </a:ext>
            </a:extLst>
          </p:cNvPr>
          <p:cNvSpPr/>
          <p:nvPr/>
        </p:nvSpPr>
        <p:spPr>
          <a:xfrm>
            <a:off x="6334525" y="2577517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AC1D673A-B686-4709-87CF-69678F27E67B}"/>
              </a:ext>
            </a:extLst>
          </p:cNvPr>
          <p:cNvSpPr/>
          <p:nvPr/>
        </p:nvSpPr>
        <p:spPr>
          <a:xfrm>
            <a:off x="6706141" y="2531709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35207494-EB65-4023-B7E2-034185755794}"/>
              </a:ext>
            </a:extLst>
          </p:cNvPr>
          <p:cNvSpPr/>
          <p:nvPr/>
        </p:nvSpPr>
        <p:spPr>
          <a:xfrm>
            <a:off x="3815581" y="2901041"/>
            <a:ext cx="255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schemeClr val="bg2">
                    <a:lumMod val="50000"/>
                  </a:schemeClr>
                </a:solidFill>
                <a:latin typeface="Arial"/>
                <a:ea typeface="Calibri" panose="020F0502020204030204" pitchFamily="34" charset="0"/>
                <a:cs typeface="Arial"/>
              </a:rPr>
              <a:t>†</a:t>
            </a:r>
            <a:endParaRPr lang="en-US" sz="1000" dirty="0">
              <a:solidFill>
                <a:schemeClr val="bg2">
                  <a:lumMod val="50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1735636" y="2398391"/>
            <a:ext cx="230638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       Total Flux (</a:t>
            </a:r>
            <a:r>
              <a:rPr lang="en-US" sz="800" dirty="0">
                <a:latin typeface="Arial"/>
                <a:cs typeface="Arial"/>
              </a:rPr>
              <a:t>photons</a:t>
            </a:r>
            <a:r>
              <a:rPr lang="en-US" sz="1000" dirty="0">
                <a:latin typeface="Arial"/>
                <a:cs typeface="Arial"/>
              </a:rPr>
              <a:t>/s/cm</a:t>
            </a:r>
            <a:r>
              <a:rPr lang="en-US" sz="1000" baseline="30000" dirty="0">
                <a:latin typeface="Arial"/>
                <a:cs typeface="Arial"/>
              </a:rPr>
              <a:t>2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589334" y="1095396"/>
            <a:ext cx="305438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/>
                <a:cs typeface="Arial"/>
              </a:rPr>
              <a:t>        In vivo </a:t>
            </a:r>
            <a:r>
              <a:rPr lang="en-US" sz="800" dirty="0">
                <a:latin typeface="Arial"/>
                <a:cs typeface="Arial"/>
              </a:rPr>
              <a:t>S. </a:t>
            </a:r>
            <a:r>
              <a:rPr lang="en-US" sz="800" dirty="0" err="1">
                <a:latin typeface="Arial"/>
                <a:cs typeface="Arial"/>
              </a:rPr>
              <a:t>aureus</a:t>
            </a:r>
            <a:r>
              <a:rPr lang="en-US" sz="800" dirty="0">
                <a:latin typeface="Arial"/>
                <a:cs typeface="Arial"/>
              </a:rPr>
              <a:t> Bioluminescence (log scale) 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270116" y="4291538"/>
            <a:ext cx="292388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                          Postoperative Day</a:t>
            </a:r>
          </a:p>
        </p:txBody>
      </p:sp>
    </p:spTree>
    <p:extLst>
      <p:ext uri="{BB962C8B-B14F-4D97-AF65-F5344CB8AC3E}">
        <p14:creationId xmlns:p14="http://schemas.microsoft.com/office/powerpoint/2010/main" val="26248565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2</Words>
  <Application>Microsoft Office PowerPoint</Application>
  <PresentationFormat>Widescreen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1</cp:revision>
  <dcterms:created xsi:type="dcterms:W3CDTF">2020-08-22T04:21:38Z</dcterms:created>
  <dcterms:modified xsi:type="dcterms:W3CDTF">2020-08-22T04:21:46Z</dcterms:modified>
</cp:coreProperties>
</file>